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9" r:id="rId3"/>
    <p:sldId id="260" r:id="rId4"/>
    <p:sldId id="257" r:id="rId5"/>
    <p:sldId id="25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16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6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kriti Krishan" userId="6a6035a6-bb44-44ac-8b13-fb6c2dedf079" providerId="ADAL" clId="{61226D7D-2B10-4FAC-BA8A-3F0319E26D03}"/>
    <pc:docChg chg="modSld">
      <pc:chgData name="Sukriti Krishan" userId="6a6035a6-bb44-44ac-8b13-fb6c2dedf079" providerId="ADAL" clId="{61226D7D-2B10-4FAC-BA8A-3F0319E26D03}" dt="2025-09-10T03:54:14.275" v="2" actId="14100"/>
      <pc:docMkLst>
        <pc:docMk/>
      </pc:docMkLst>
      <pc:sldChg chg="modSp mod">
        <pc:chgData name="Sukriti Krishan" userId="6a6035a6-bb44-44ac-8b13-fb6c2dedf079" providerId="ADAL" clId="{61226D7D-2B10-4FAC-BA8A-3F0319E26D03}" dt="2025-09-10T03:54:14.275" v="2" actId="14100"/>
        <pc:sldMkLst>
          <pc:docMk/>
          <pc:sldMk cId="458985131" sldId="257"/>
        </pc:sldMkLst>
        <pc:picChg chg="mod">
          <ac:chgData name="Sukriti Krishan" userId="6a6035a6-bb44-44ac-8b13-fb6c2dedf079" providerId="ADAL" clId="{61226D7D-2B10-4FAC-BA8A-3F0319E26D03}" dt="2025-09-10T03:54:14.275" v="2" actId="14100"/>
          <ac:picMkLst>
            <pc:docMk/>
            <pc:sldMk cId="458985131" sldId="257"/>
            <ac:picMk id="28" creationId="{46BE3045-096B-F53A-328F-5C16599204D0}"/>
          </ac:picMkLst>
        </pc:picChg>
      </pc:sldChg>
      <pc:sldChg chg="modSp mod">
        <pc:chgData name="Sukriti Krishan" userId="6a6035a6-bb44-44ac-8b13-fb6c2dedf079" providerId="ADAL" clId="{61226D7D-2B10-4FAC-BA8A-3F0319E26D03}" dt="2025-09-10T03:51:08.467" v="1" actId="20577"/>
        <pc:sldMkLst>
          <pc:docMk/>
          <pc:sldMk cId="2683156210" sldId="258"/>
        </pc:sldMkLst>
        <pc:spChg chg="mod">
          <ac:chgData name="Sukriti Krishan" userId="6a6035a6-bb44-44ac-8b13-fb6c2dedf079" providerId="ADAL" clId="{61226D7D-2B10-4FAC-BA8A-3F0319E26D03}" dt="2025-09-10T03:51:08.467" v="1" actId="20577"/>
          <ac:spMkLst>
            <pc:docMk/>
            <pc:sldMk cId="2683156210" sldId="258"/>
            <ac:spMk id="4" creationId="{74DBB6D9-8C65-BD25-AE64-A3B73892CF9A}"/>
          </ac:spMkLst>
        </pc:spChg>
      </pc:sldChg>
    </pc:docChg>
  </pc:docChgLst>
  <pc:docChgLst>
    <pc:chgData name="Sukriti Krishan" userId="6a6035a6-bb44-44ac-8b13-fb6c2dedf079" providerId="ADAL" clId="{C14108BB-2D99-42B2-A361-474788FA08EB}"/>
    <pc:docChg chg="undo custSel addSld delSld modSld sldOrd">
      <pc:chgData name="Sukriti Krishan" userId="6a6035a6-bb44-44ac-8b13-fb6c2dedf079" providerId="ADAL" clId="{C14108BB-2D99-42B2-A361-474788FA08EB}" dt="2025-08-18T03:51:47.829" v="139" actId="208"/>
      <pc:docMkLst>
        <pc:docMk/>
      </pc:docMkLst>
      <pc:sldChg chg="modSp mod">
        <pc:chgData name="Sukriti Krishan" userId="6a6035a6-bb44-44ac-8b13-fb6c2dedf079" providerId="ADAL" clId="{C14108BB-2D99-42B2-A361-474788FA08EB}" dt="2025-08-14T05:55:15.964" v="82" actId="208"/>
        <pc:sldMkLst>
          <pc:docMk/>
          <pc:sldMk cId="3128922752" sldId="256"/>
        </pc:sldMkLst>
        <pc:picChg chg="mod">
          <ac:chgData name="Sukriti Krishan" userId="6a6035a6-bb44-44ac-8b13-fb6c2dedf079" providerId="ADAL" clId="{C14108BB-2D99-42B2-A361-474788FA08EB}" dt="2025-08-14T05:55:15.964" v="82" actId="208"/>
          <ac:picMkLst>
            <pc:docMk/>
            <pc:sldMk cId="3128922752" sldId="256"/>
            <ac:picMk id="4" creationId="{B5B61DFA-A6F2-535B-E33D-CD7E0B1D1C60}"/>
          </ac:picMkLst>
        </pc:picChg>
      </pc:sldChg>
      <pc:sldChg chg="addSp delSp modSp mod ord">
        <pc:chgData name="Sukriti Krishan" userId="6a6035a6-bb44-44ac-8b13-fb6c2dedf079" providerId="ADAL" clId="{C14108BB-2D99-42B2-A361-474788FA08EB}" dt="2025-08-18T03:51:47.829" v="139" actId="208"/>
        <pc:sldMkLst>
          <pc:docMk/>
          <pc:sldMk cId="458985131" sldId="257"/>
        </pc:sldMkLst>
        <pc:spChg chg="mod">
          <ac:chgData name="Sukriti Krishan" userId="6a6035a6-bb44-44ac-8b13-fb6c2dedf079" providerId="ADAL" clId="{C14108BB-2D99-42B2-A361-474788FA08EB}" dt="2025-08-18T03:49:23.643" v="116" actId="20577"/>
          <ac:spMkLst>
            <pc:docMk/>
            <pc:sldMk cId="458985131" sldId="257"/>
            <ac:spMk id="5" creationId="{D2E71D27-6535-FC00-1E60-5FCB6B23E4B9}"/>
          </ac:spMkLst>
        </pc:spChg>
        <pc:spChg chg="mod">
          <ac:chgData name="Sukriti Krishan" userId="6a6035a6-bb44-44ac-8b13-fb6c2dedf079" providerId="ADAL" clId="{C14108BB-2D99-42B2-A361-474788FA08EB}" dt="2025-08-14T05:55:34.582" v="92" actId="1076"/>
          <ac:spMkLst>
            <pc:docMk/>
            <pc:sldMk cId="458985131" sldId="257"/>
            <ac:spMk id="6" creationId="{B4AC7828-1A37-A0B9-D9C3-2CB518C821ED}"/>
          </ac:spMkLst>
        </pc:spChg>
        <pc:picChg chg="add mod">
          <ac:chgData name="Sukriti Krishan" userId="6a6035a6-bb44-44ac-8b13-fb6c2dedf079" providerId="ADAL" clId="{C14108BB-2D99-42B2-A361-474788FA08EB}" dt="2025-08-18T03:51:47.829" v="139" actId="208"/>
          <ac:picMkLst>
            <pc:docMk/>
            <pc:sldMk cId="458985131" sldId="257"/>
            <ac:picMk id="28" creationId="{46BE3045-096B-F53A-328F-5C16599204D0}"/>
          </ac:picMkLst>
        </pc:picChg>
      </pc:sldChg>
      <pc:sldChg chg="addSp delSp modSp new mod">
        <pc:chgData name="Sukriti Krishan" userId="6a6035a6-bb44-44ac-8b13-fb6c2dedf079" providerId="ADAL" clId="{C14108BB-2D99-42B2-A361-474788FA08EB}" dt="2025-08-14T05:55:38.924" v="93" actId="208"/>
        <pc:sldMkLst>
          <pc:docMk/>
          <pc:sldMk cId="2683156210" sldId="258"/>
        </pc:sldMkLst>
        <pc:spChg chg="add mod">
          <ac:chgData name="Sukriti Krishan" userId="6a6035a6-bb44-44ac-8b13-fb6c2dedf079" providerId="ADAL" clId="{C14108BB-2D99-42B2-A361-474788FA08EB}" dt="2025-08-14T05:53:48.832" v="4" actId="20577"/>
          <ac:spMkLst>
            <pc:docMk/>
            <pc:sldMk cId="2683156210" sldId="258"/>
            <ac:spMk id="4" creationId="{74DBB6D9-8C65-BD25-AE64-A3B73892CF9A}"/>
          </ac:spMkLst>
        </pc:spChg>
        <pc:spChg chg="add mod">
          <ac:chgData name="Sukriti Krishan" userId="6a6035a6-bb44-44ac-8b13-fb6c2dedf079" providerId="ADAL" clId="{C14108BB-2D99-42B2-A361-474788FA08EB}" dt="2025-08-14T05:54:26.777" v="78" actId="20577"/>
          <ac:spMkLst>
            <pc:docMk/>
            <pc:sldMk cId="2683156210" sldId="258"/>
            <ac:spMk id="5" creationId="{F7988EC0-D54E-4F73-1084-99A04BD98C8C}"/>
          </ac:spMkLst>
        </pc:spChg>
        <pc:picChg chg="add mod">
          <ac:chgData name="Sukriti Krishan" userId="6a6035a6-bb44-44ac-8b13-fb6c2dedf079" providerId="ADAL" clId="{C14108BB-2D99-42B2-A361-474788FA08EB}" dt="2025-08-14T05:55:38.924" v="93" actId="208"/>
          <ac:picMkLst>
            <pc:docMk/>
            <pc:sldMk cId="2683156210" sldId="258"/>
            <ac:picMk id="15" creationId="{FFFB12B0-B03F-8559-AC0A-FB01F63D96EF}"/>
          </ac:picMkLst>
        </pc:picChg>
      </pc:sldChg>
      <pc:sldChg chg="addSp delSp modSp new del mod">
        <pc:chgData name="Sukriti Krishan" userId="6a6035a6-bb44-44ac-8b13-fb6c2dedf079" providerId="ADAL" clId="{C14108BB-2D99-42B2-A361-474788FA08EB}" dt="2025-08-18T01:52:01.738" v="100" actId="47"/>
        <pc:sldMkLst>
          <pc:docMk/>
          <pc:sldMk cId="2283344524" sldId="259"/>
        </pc:sldMkLst>
      </pc:sldChg>
      <pc:sldChg chg="addSp delSp modSp add mod modNotesTx">
        <pc:chgData name="Sukriti Krishan" userId="6a6035a6-bb44-44ac-8b13-fb6c2dedf079" providerId="ADAL" clId="{C14108BB-2D99-42B2-A361-474788FA08EB}" dt="2025-08-18T03:51:34.690" v="138" actId="478"/>
        <pc:sldMkLst>
          <pc:docMk/>
          <pc:sldMk cId="2868121719" sldId="259"/>
        </pc:sldMkLst>
        <pc:spChg chg="add mod">
          <ac:chgData name="Sukriti Krishan" userId="6a6035a6-bb44-44ac-8b13-fb6c2dedf079" providerId="ADAL" clId="{C14108BB-2D99-42B2-A361-474788FA08EB}" dt="2025-08-18T03:51:31.770" v="137" actId="1076"/>
          <ac:spMkLst>
            <pc:docMk/>
            <pc:sldMk cId="2868121719" sldId="259"/>
            <ac:spMk id="39" creationId="{48C3883A-22DF-05C1-1E73-F756C75B7618}"/>
          </ac:spMkLst>
        </pc:spChg>
        <pc:picChg chg="add mod">
          <ac:chgData name="Sukriti Krishan" userId="6a6035a6-bb44-44ac-8b13-fb6c2dedf079" providerId="ADAL" clId="{C14108BB-2D99-42B2-A361-474788FA08EB}" dt="2025-08-18T03:51:28.027" v="135" actId="1076"/>
          <ac:picMkLst>
            <pc:docMk/>
            <pc:sldMk cId="2868121719" sldId="259"/>
            <ac:picMk id="37" creationId="{0F58ACA0-33B9-9B66-9EE6-2F485E0EC510}"/>
          </ac:picMkLst>
        </pc:picChg>
      </pc:sldChg>
      <pc:sldChg chg="addSp delSp modSp add mod modNotesTx">
        <pc:chgData name="Sukriti Krishan" userId="6a6035a6-bb44-44ac-8b13-fb6c2dedf079" providerId="ADAL" clId="{C14108BB-2D99-42B2-A361-474788FA08EB}" dt="2025-08-18T03:51:16.956" v="134" actId="1076"/>
        <pc:sldMkLst>
          <pc:docMk/>
          <pc:sldMk cId="3379683692" sldId="260"/>
        </pc:sldMkLst>
        <pc:spChg chg="add mod">
          <ac:chgData name="Sukriti Krishan" userId="6a6035a6-bb44-44ac-8b13-fb6c2dedf079" providerId="ADAL" clId="{C14108BB-2D99-42B2-A361-474788FA08EB}" dt="2025-08-18T03:51:09.807" v="131" actId="1076"/>
          <ac:spMkLst>
            <pc:docMk/>
            <pc:sldMk cId="3379683692" sldId="260"/>
            <ac:spMk id="31" creationId="{6D215867-7345-2961-CC68-F84EAD48538B}"/>
          </ac:spMkLst>
        </pc:spChg>
        <pc:picChg chg="add mod">
          <ac:chgData name="Sukriti Krishan" userId="6a6035a6-bb44-44ac-8b13-fb6c2dedf079" providerId="ADAL" clId="{C14108BB-2D99-42B2-A361-474788FA08EB}" dt="2025-08-18T03:51:16.956" v="134" actId="1076"/>
          <ac:picMkLst>
            <pc:docMk/>
            <pc:sldMk cId="3379683692" sldId="260"/>
            <ac:picMk id="27" creationId="{8A90A39A-70B4-12A6-01BF-50CDDA230EB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24108F-5EBE-4A53-A422-5AEB29588F97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50C7E8-BFFC-498D-96E9-8940DA3B0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19450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2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 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ngle-cell RNA sequencing analysis of the </a:t>
            </a:r>
            <a:r>
              <a:rPr lang="en-AU" sz="1200" b="1" i="1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Batlas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br>
              <a:rPr lang="en-AU" dirty="0"/>
            </a:br>
            <a:r>
              <a:rPr lang="en-AU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Batlas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ata were obtained from Bonine </a:t>
            </a:r>
            <a:r>
              <a:rPr lang="en-AU" sz="12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t al.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(2024) (PMID: 39368085).</a:t>
            </a:r>
            <a:br>
              <a:rPr lang="en-AU" dirty="0"/>
            </a:b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UMAP of 362,991 single cells and nuclei from all cell types across multiple neuroblastoma datasets. Cell type annotations were annotated based on Bonine </a:t>
            </a:r>
            <a:r>
              <a:rPr lang="en-AU" sz="12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t al.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(2024).</a:t>
            </a:r>
            <a:br>
              <a:rPr lang="en-AU" dirty="0"/>
            </a:b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UMAP of malignant and normal neuroendocrine cells after filtering. Malignancy status was assigned according to CNV inference results reported in Bonine </a:t>
            </a:r>
            <a:r>
              <a:rPr lang="en-AU" sz="12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t al.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(2024). Patients with fewer than 100 neuroendocrine cells, or with fewer than 100 malignant or 100 normal neuroendocrine cells, were excluded from downstream </a:t>
            </a:r>
            <a:r>
              <a:rPr lang="en-AU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seudobulk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single-cell correlation analyses of 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2G4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 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N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 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After filtering, </a:t>
            </a:r>
            <a:r>
              <a:rPr lang="en-AU" sz="12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= 213,249 neuroendocrine cells remained: malignant (</a:t>
            </a:r>
            <a:r>
              <a:rPr lang="en-AU" sz="12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= 125,005) and normal (</a:t>
            </a:r>
            <a:r>
              <a:rPr lang="en-AU" sz="12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= 88,244).</a:t>
            </a:r>
            <a:br>
              <a:rPr lang="en-AU" dirty="0"/>
            </a:br>
            <a:r>
              <a:rPr lang="en-AU" dirty="0"/>
              <a:t>(c) 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eature plot (left panel) and Dot plot (right panel) of PA2G4, MYCN, and MYC.</a:t>
            </a:r>
            <a:endParaRPr lang="en-AU" b="0" dirty="0"/>
          </a:p>
          <a:p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 Single-cell–level Spearman correlation analysis of 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2G4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with 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N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and 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for malignant (</a:t>
            </a:r>
            <a:r>
              <a:rPr lang="en-AU" sz="12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= 125,005) and normal (</a:t>
            </a:r>
            <a:r>
              <a:rPr lang="en-AU" sz="12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= 88,244) neuroendocrine cells.</a:t>
            </a:r>
            <a:br>
              <a:rPr lang="en-AU" dirty="0"/>
            </a:b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e) </a:t>
            </a:r>
            <a:r>
              <a:rPr lang="en-AU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seudobulk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level Spearman correlation analysis at the patient level for malignant and normal neuroendocrine cells (n = x patients).</a:t>
            </a: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7BDFEF-268A-644F-AB81-796EE5D6621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1729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3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 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ngle-cell RNA sequencing analysis of the </a:t>
            </a:r>
            <a:r>
              <a:rPr lang="en-AU" sz="1200" b="1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renal medulla datasets.</a:t>
            </a:r>
            <a:br>
              <a:rPr lang="en-AU" dirty="0"/>
            </a:b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renal medulla dataset were obtained from Jansky et al. (2021) (PMID: 33767450). Datasets were downloaded from https://</a:t>
            </a:r>
            <a:r>
              <a:rPr lang="en-AU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renal.kitz-heidelberg.de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</a:t>
            </a:r>
            <a:r>
              <a:rPr lang="en-AU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velopmental_programs_NB_viz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br>
              <a:rPr lang="en-AU" dirty="0"/>
            </a:b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UMAP of 10,739 single-nuclei RNA of </a:t>
            </a:r>
            <a:r>
              <a:rPr lang="en-AU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etal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renal medulla cells coloured by cell types annotated by Jansky et al. (2021). </a:t>
            </a:r>
          </a:p>
          <a:p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Feature plot (left panel) and Dot plot (right panel) of PA2G4, MYCN, and MYC expression in </a:t>
            </a:r>
            <a:r>
              <a:rPr lang="en-AU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etal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renal medulla dataset showing minimal expression of all three genes in adrenal medullary cells.</a:t>
            </a:r>
          </a:p>
          <a:p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 UMAP of 957 single-nuclei RNA of adrenal medullary cells from adrenal medulla at 8 weeks postconception adrenal medulla dataset annotated by Jansky et al. (2021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 Feature plot (left panel) and Dot plot (right panel) of PA2G4, MYCN, and MYC in 8 weeks postconception adrenal medulla dataset also showing minimal expression of all three genes in adrenal medullary cells.</a:t>
            </a:r>
          </a:p>
          <a:p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ngle-cell–level Spearman correlation analysis of 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2G4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with 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N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and </a:t>
            </a:r>
            <a:r>
              <a:rPr lang="en-AU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for (e) </a:t>
            </a:r>
            <a:r>
              <a:rPr lang="en-AU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etal</a:t>
            </a:r>
            <a:r>
              <a:rPr lang="en-AU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renal medulla and (f) 8 PCW adrenal medulla datasets.</a:t>
            </a:r>
            <a:br>
              <a:rPr lang="en-AU" dirty="0"/>
            </a:b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7BDFEF-268A-644F-AB81-796EE5D6621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8044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8D961B-ABC6-E5FB-AD59-E4CE814329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FC167F-DD9F-A5DA-B784-85EDFB7088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FBDB38-4D96-50F7-9710-EBD1F0AD6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3AB753-5818-8A72-930B-0AFD530F58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59ABE-B184-8254-9FDE-B67547D91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32078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F770C5-7D40-FC9F-247B-C8B3E4D0F3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09FDDA-F2FE-C7C6-F811-6FB373876C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95254F-C5CA-196A-650B-04EF2C8646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D6EE32-C7AD-38F4-1014-E003E3540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AD904F-DEF4-25BD-A7BD-0319E68A5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33269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1CB4737-B01B-20AF-D67B-515853811A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7DE73B-2102-C5AA-7471-969D892E08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3B3655-1439-3BA5-0497-A283D8BFB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959773-428A-5AC8-A106-9EF305B13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701EFE-F499-3BC2-9A86-DEA7AD436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54046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12C826-0C4F-A152-12EE-9A9ACD02E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B4D41A-5656-D98D-BF9C-8D6356D22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1BE335-97BC-32F8-38D2-411DFD4E81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D53019-4363-600A-A531-1A4576598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2C81D6-3283-64A0-21A1-451409328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4568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560759-7E1D-C996-0482-E58569FE7E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59C559-A7A5-2039-3A2A-6F7BA9246F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A74D71-0D63-20ED-892D-3A92EC1D49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59219F-5BE4-1F7E-9B0D-F6FCB4466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C4BD53-80F0-D284-5065-77B12F06E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0276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0BF8F0-4FFC-526B-0647-D87414CE2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29E8AE-EAA4-9E50-B45B-3075772CC0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28378D-CBC2-7104-547C-69D869BA67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6096C6-FF3C-64FC-93FE-133FB4D01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1B34A2-4836-E346-6170-B9E08BB34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B91AB9-1B57-9F76-E508-969FE9B54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3248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09C095-BF20-C9AE-4A46-2DD60FEA43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3B64FC-7B21-5B85-3163-5BC7EAE1B4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13385E-FF47-D3E5-CD89-1A875C4632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8968E4E-346E-D082-7660-39D84A2EB9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2163DA-78A1-1DA4-770A-F7A4E46653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5BFA725-6D12-BE35-BF7F-F374112719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58F847F-887A-56C6-AC66-04A5FF3C2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7AC6DF2-D51C-7823-005A-6959515F2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3580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9B295D-F7CB-9D17-0A6F-3122BAB76E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D622FD0-4DC6-FF35-4BD3-18C6E33F5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BB20B0C-80A7-D75A-EA35-CDD2B5281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39FBA40-81CC-5E95-FCBD-6227393B1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1808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FB93E20-9C05-D14A-BB78-FFA54FC56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C4A84A0-83AA-4712-38D1-C315A03D2C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7BD34F6-CE84-806B-E609-10EB0458B6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94883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E37E7-8918-AEC0-329C-CFEAA04A0F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D5D835-8718-ECC7-C5FD-7FD0317781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9C7147-C5A1-1408-DDF0-26A3A3D8EC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2F306A-8F09-8EC9-5F65-6C6896D9C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67DF7E-3EE7-DA54-4F3C-CF6E70F75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1C6A63-BE17-B4C9-CA48-E7981F202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4728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0D22E3-3119-B7CD-CBFD-67835B9DF9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64E919D-8D08-8DC0-65A1-49DD1C4F23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5EA6F0-E15E-7C1C-469E-E504B0E281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6B06A8-E206-EDF7-04A9-E6A33D51F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755213-20CB-B9BD-DB2D-1D3500192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932368-8503-F47C-8C38-3AFD4CD179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93129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57FD916-C7BB-98B4-D3FA-BCCBD8E663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87CBDB-8367-9FA5-BB4E-DF7FBEC544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AD3195-B733-6C70-E36A-F0E84352C1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8518C6-5397-4D82-A397-EF1B75099602}" type="datetimeFigureOut">
              <a:rPr lang="en-AU" smtClean="0"/>
              <a:t>11/09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27A5A5-76E6-F177-3012-58F8142CC4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F44C09-5D3C-F465-6978-735495989C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138611A-3325-4072-A0A8-3E2D5A9AEF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6729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5B61DFA-A6F2-535B-E33D-CD7E0B1D1C6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65" r="8154"/>
          <a:stretch/>
        </p:blipFill>
        <p:spPr bwMode="auto">
          <a:xfrm>
            <a:off x="649378" y="375442"/>
            <a:ext cx="7998436" cy="5266396"/>
          </a:xfrm>
          <a:prstGeom prst="rect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none" w="med" len="med"/>
            <a:extLst>
              <a:ext uri="{C807C97D-BFC1-408E-A445-0C87EB9F89A2}">
                <ask:lineSketchStyleProps xmlns:ask="http://schemas.microsoft.com/office/drawing/2018/sketchyshapes" sd="0">
                  <a:custGeom>
                    <a:avLst/>
                    <a:gdLst/>
                    <a:ahLst/>
                    <a:cxnLst/>
                    <a:rect l="0" t="0" r="0" b="0"/>
                    <a:pathLst/>
                  </a:custGeom>
                  <ask:type/>
                </ask:lineSketchStyleProps>
              </a:ext>
            </a:extLst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0678AE6-BFD4-D2BE-9F23-2542FD6DEAB6}"/>
              </a:ext>
            </a:extLst>
          </p:cNvPr>
          <p:cNvSpPr txBox="1"/>
          <p:nvPr/>
        </p:nvSpPr>
        <p:spPr>
          <a:xfrm>
            <a:off x="579101" y="5716851"/>
            <a:ext cx="6094476" cy="3681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en-GB" sz="1800" b="1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Supplementary Figure S1</a:t>
            </a:r>
            <a:endParaRPr lang="en-AU" sz="1200" kern="100" dirty="0">
              <a:effectLst/>
              <a:latin typeface="Lucida Sans" panose="020B0602030504020204" pitchFamily="34" charset="0"/>
              <a:ea typeface="SimSun" panose="02010600030101010101" pitchFamily="2" charset="-122"/>
              <a:cs typeface="Cordia New" panose="020B0304020202020204" pitchFamily="34" charset="-34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13F4518-9E34-B465-351E-BABCBDD34C4F}"/>
              </a:ext>
            </a:extLst>
          </p:cNvPr>
          <p:cNvSpPr txBox="1"/>
          <p:nvPr/>
        </p:nvSpPr>
        <p:spPr>
          <a:xfrm>
            <a:off x="579101" y="6018720"/>
            <a:ext cx="11443438" cy="6645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Immunohistochemical staining for PA2G4 and MYCN protein in tumour samples from </a:t>
            </a:r>
            <a:r>
              <a:rPr lang="en-AU" sz="1800" i="1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Th-MYCN x PA2G4 </a:t>
            </a:r>
            <a:r>
              <a:rPr lang="en-AU" sz="1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mice using an anti-mouse PA2G4 and anti-mouse MYCN antibodies</a:t>
            </a:r>
            <a:endParaRPr lang="en-AU" sz="1200" kern="100" dirty="0">
              <a:effectLst/>
              <a:latin typeface="Lucida Sans" panose="020B0602030504020204" pitchFamily="34" charset="0"/>
              <a:ea typeface="SimSun" panose="02010600030101010101" pitchFamily="2" charset="-122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1289227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Picture 36">
            <a:extLst>
              <a:ext uri="{FF2B5EF4-FFF2-40B4-BE49-F238E27FC236}">
                <a16:creationId xmlns:a16="http://schemas.microsoft.com/office/drawing/2014/main" id="{0F58ACA0-33B9-9B66-9EE6-2F485E0EC5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8747" y="284052"/>
            <a:ext cx="4718713" cy="64135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48C3883A-22DF-05C1-1E73-F756C75B7618}"/>
              </a:ext>
            </a:extLst>
          </p:cNvPr>
          <p:cNvSpPr txBox="1"/>
          <p:nvPr/>
        </p:nvSpPr>
        <p:spPr>
          <a:xfrm>
            <a:off x="5409576" y="58846"/>
            <a:ext cx="6097248" cy="67403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2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 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ngle-cell RNA sequencing analysis of the </a:t>
            </a:r>
            <a:r>
              <a:rPr lang="en-AU" sz="1800" b="1" i="1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Batlas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br>
              <a:rPr lang="en-AU" dirty="0"/>
            </a:br>
            <a:r>
              <a:rPr lang="en-AU" sz="18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Batlas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ata were obtained from Bonine </a:t>
            </a:r>
            <a:r>
              <a:rPr lang="en-AU" sz="18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t al.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(2024) (PMID: 39368085).</a:t>
            </a:r>
            <a:br>
              <a:rPr lang="en-AU" dirty="0"/>
            </a:b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UMAP of 362,991 single cells and nuclei from all cell types across multiple neuroblastoma datasets. Cell type annotations were annotated based on Bonine </a:t>
            </a:r>
            <a:r>
              <a:rPr lang="en-AU" sz="18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t al.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(2024).</a:t>
            </a:r>
            <a:br>
              <a:rPr lang="en-AU" dirty="0"/>
            </a:b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UMAP of malignant and normal neuroendocrine cells after filtering. Malignancy status was assigned according to CNV inference results reported in Bonine </a:t>
            </a:r>
            <a:r>
              <a:rPr lang="en-AU" sz="18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t al.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(2024). Patients with fewer than 100 neuroendocrine cells, or with fewer than 100 malignant or 100 normal neuroendocrine cells, were excluded from downstream </a:t>
            </a:r>
            <a:r>
              <a:rPr lang="en-AU" sz="18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seudobulk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single-cell correlation analyses of 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2G4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 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N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 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After filtering, </a:t>
            </a:r>
            <a:r>
              <a:rPr lang="en-AU" sz="18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= 213,249 neuroendocrine cells remained: malignant (</a:t>
            </a:r>
            <a:r>
              <a:rPr lang="en-AU" sz="18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= 125,005) and normal (</a:t>
            </a:r>
            <a:r>
              <a:rPr lang="en-AU" sz="18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= 88,244).</a:t>
            </a:r>
            <a:br>
              <a:rPr lang="en-AU" dirty="0"/>
            </a:br>
            <a:r>
              <a:rPr lang="en-AU" dirty="0"/>
              <a:t>(c) 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eature plot (left panel) and Dot plot (right panel) of PA2G4, MYCN, and MYC.</a:t>
            </a:r>
            <a:endParaRPr lang="en-AU" b="0" dirty="0"/>
          </a:p>
          <a:p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 Single-cell–level Spearman correlation analysis of 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2G4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with 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N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and 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for malignant (</a:t>
            </a:r>
            <a:r>
              <a:rPr lang="en-AU" sz="18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= 125,005) and normal (</a:t>
            </a:r>
            <a:r>
              <a:rPr lang="en-AU" sz="1800" b="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= 88,244) neuroendocrine cells.</a:t>
            </a:r>
            <a:br>
              <a:rPr lang="en-AU" dirty="0"/>
            </a:b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e) </a:t>
            </a:r>
            <a:r>
              <a:rPr lang="en-AU" sz="18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seudobulk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level Spearman correlation analysis at the patient level for malignant and normal neuroendocrine cells (n = x patients).</a:t>
            </a:r>
            <a:endParaRPr lang="en-US" b="0" dirty="0"/>
          </a:p>
        </p:txBody>
      </p:sp>
    </p:spTree>
    <p:extLst>
      <p:ext uri="{BB962C8B-B14F-4D97-AF65-F5344CB8AC3E}">
        <p14:creationId xmlns:p14="http://schemas.microsoft.com/office/powerpoint/2010/main" val="28681217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8A90A39A-70B4-12A6-01BF-50CDDA230E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944" y="0"/>
            <a:ext cx="4718713" cy="68464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6D215867-7345-2961-CC68-F84EAD48538B}"/>
              </a:ext>
            </a:extLst>
          </p:cNvPr>
          <p:cNvSpPr txBox="1"/>
          <p:nvPr/>
        </p:nvSpPr>
        <p:spPr>
          <a:xfrm>
            <a:off x="6006362" y="142026"/>
            <a:ext cx="6097248" cy="67403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3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 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ngle-cell RNA sequencing analysis of the </a:t>
            </a:r>
            <a:r>
              <a:rPr lang="en-AU" sz="1800" b="1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renal medulla datasets.</a:t>
            </a:r>
            <a:br>
              <a:rPr lang="en-AU" dirty="0"/>
            </a:b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renal medulla dataset were obtained from Jansky et al. (2021) (PMID: 33767450). Datasets were downloaded from https://adrenal.kitz-heidelberg.de/developmental_programs_NB_viz.</a:t>
            </a:r>
            <a:br>
              <a:rPr lang="en-AU" dirty="0"/>
            </a:b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UMAP of 10,739 single-nuclei RNA of </a:t>
            </a:r>
            <a:r>
              <a:rPr lang="en-AU" sz="18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etal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renal medulla cells coloured by cell types annotated by Jansky et al. (2021). </a:t>
            </a:r>
          </a:p>
          <a:p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Feature plot (left panel) and Dot plot (right panel) of PA2G4, MYCN, and MYC expression in </a:t>
            </a:r>
            <a:r>
              <a:rPr lang="en-AU" sz="18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etal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renal medulla dataset showing minimal expression of all three genes in adrenal medullary cells.</a:t>
            </a:r>
          </a:p>
          <a:p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 UMAP of 957 single-nuclei RNA of adrenal medullary cells from adrenal medulla at 8 weeks postconception adrenal medulla dataset annotated by Jansky et al. (2021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 Feature plot (left panel) and Dot plot (right panel) of PA2G4, MYCN, and MYC in 8 weeks postconception adrenal medulla dataset also showing minimal expression of all three genes in adrenal medullary cells.</a:t>
            </a:r>
          </a:p>
          <a:p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ngle-cell–level Spearman correlation analysis of 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2G4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with 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N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and </a:t>
            </a:r>
            <a:r>
              <a:rPr lang="en-AU" sz="18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for (e) </a:t>
            </a:r>
            <a:r>
              <a:rPr lang="en-AU" sz="18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etal</a:t>
            </a:r>
            <a:r>
              <a:rPr lang="en-AU" sz="18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renal medulla and (f) 8 PCW adrenal medulla datasets.</a:t>
            </a:r>
            <a:br>
              <a:rPr lang="en-AU" dirty="0"/>
            </a:br>
            <a:endParaRPr lang="en-US" b="0" dirty="0"/>
          </a:p>
        </p:txBody>
      </p:sp>
    </p:spTree>
    <p:extLst>
      <p:ext uri="{BB962C8B-B14F-4D97-AF65-F5344CB8AC3E}">
        <p14:creationId xmlns:p14="http://schemas.microsoft.com/office/powerpoint/2010/main" val="33796836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2E71D27-6535-FC00-1E60-5FCB6B23E4B9}"/>
              </a:ext>
            </a:extLst>
          </p:cNvPr>
          <p:cNvSpPr txBox="1"/>
          <p:nvPr/>
        </p:nvSpPr>
        <p:spPr>
          <a:xfrm>
            <a:off x="81013" y="5891590"/>
            <a:ext cx="6094476" cy="3681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en-GB" sz="1800" b="1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Supplementary Figure S4</a:t>
            </a:r>
            <a:endParaRPr lang="en-AU" sz="1200" kern="100" dirty="0">
              <a:effectLst/>
              <a:latin typeface="Lucida Sans" panose="020B0602030504020204" pitchFamily="34" charset="0"/>
              <a:ea typeface="SimSun" panose="02010600030101010101" pitchFamily="2" charset="-122"/>
              <a:cs typeface="Cordia New" panose="020B0304020202020204" pitchFamily="34" charset="-34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4AC7828-1A37-A0B9-D9C3-2CB518C821ED}"/>
              </a:ext>
            </a:extLst>
          </p:cNvPr>
          <p:cNvSpPr txBox="1"/>
          <p:nvPr/>
        </p:nvSpPr>
        <p:spPr>
          <a:xfrm>
            <a:off x="81013" y="6193459"/>
            <a:ext cx="11443438" cy="6645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Cell viability assays of SH-SY5Y, SK-N-AS, DAOY, UW-288, Raji, WEHI-47, KOPN8, SEMK2, WEHI-116, and normal fibroblasts (MRC5 and WI-38) after treatment with WS6 (0–8 </a:t>
            </a:r>
            <a:r>
              <a:rPr lang="el-GR" sz="1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μ</a:t>
            </a:r>
            <a:r>
              <a:rPr lang="en-AU" sz="1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M) for 72 hours.</a:t>
            </a:r>
            <a:endParaRPr lang="en-AU" sz="1200" kern="100" dirty="0">
              <a:effectLst/>
              <a:latin typeface="Lucida Sans" panose="020B0602030504020204" pitchFamily="34" charset="0"/>
              <a:ea typeface="SimSun" panose="02010600030101010101" pitchFamily="2" charset="-122"/>
              <a:cs typeface="Cordia New" panose="020B0304020202020204" pitchFamily="34" charset="-34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46BE3045-096B-F53A-328F-5C16599204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2386" y="0"/>
            <a:ext cx="9024563" cy="576947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589851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4DBB6D9-8C65-BD25-AE64-A3B73892CF9A}"/>
              </a:ext>
            </a:extLst>
          </p:cNvPr>
          <p:cNvSpPr txBox="1"/>
          <p:nvPr/>
        </p:nvSpPr>
        <p:spPr>
          <a:xfrm>
            <a:off x="579101" y="5716851"/>
            <a:ext cx="6094476" cy="3681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en-GB" sz="1800" b="1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Supplementary </a:t>
            </a:r>
            <a:r>
              <a:rPr lang="en-GB" sz="1800" b="1" kern="10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Figure S5</a:t>
            </a:r>
            <a:endParaRPr lang="en-AU" sz="1200" kern="100" dirty="0">
              <a:effectLst/>
              <a:latin typeface="Lucida Sans" panose="020B0602030504020204" pitchFamily="34" charset="0"/>
              <a:ea typeface="SimSun" panose="02010600030101010101" pitchFamily="2" charset="-122"/>
              <a:cs typeface="Cordia New" panose="020B0304020202020204" pitchFamily="34" charset="-34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7988EC0-D54E-4F73-1084-99A04BD98C8C}"/>
              </a:ext>
            </a:extLst>
          </p:cNvPr>
          <p:cNvSpPr txBox="1"/>
          <p:nvPr/>
        </p:nvSpPr>
        <p:spPr>
          <a:xfrm>
            <a:off x="579101" y="6018720"/>
            <a:ext cx="11443438" cy="3681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en-GB" sz="1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BLISS Synergy maps for WS6 + </a:t>
            </a:r>
            <a:r>
              <a:rPr lang="en-GB" kern="100" dirty="0"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Vincristine, WS6 + Cisplatin and WS6 + Etoposide </a:t>
            </a:r>
            <a:endParaRPr lang="en-AU" sz="1200" kern="100" dirty="0">
              <a:effectLst/>
              <a:latin typeface="Lucida Sans" panose="020B0602030504020204" pitchFamily="34" charset="0"/>
              <a:ea typeface="SimSun" panose="02010600030101010101" pitchFamily="2" charset="-122"/>
              <a:cs typeface="Cordia New" panose="020B0304020202020204" pitchFamily="34" charset="-34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FFB12B0-B03F-8559-AC0A-FB01F63D96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8269" y="1981074"/>
            <a:ext cx="10955462" cy="289585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683156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1</TotalTime>
  <Words>1020</Words>
  <Application>Microsoft Office PowerPoint</Application>
  <PresentationFormat>Widescreen</PresentationFormat>
  <Paragraphs>22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Lucida San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kriti Krishan</dc:creator>
  <cp:lastModifiedBy>MDPI</cp:lastModifiedBy>
  <cp:revision>4</cp:revision>
  <dcterms:created xsi:type="dcterms:W3CDTF">2025-07-14T05:45:24Z</dcterms:created>
  <dcterms:modified xsi:type="dcterms:W3CDTF">2025-09-11T04:26:54Z</dcterms:modified>
</cp:coreProperties>
</file>